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9144000" cy="6858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93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9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33" name="Picture 32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  <p:pic>
        <p:nvPicPr>
          <p:cNvPr id="34" name="Picture 33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1680" cy="68115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3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680" cy="1469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CustomShape 1"/>
          <p:cNvSpPr/>
          <p:nvPr/>
        </p:nvSpPr>
        <p:spPr>
          <a:xfrm>
            <a:off x="606600" y="6017040"/>
            <a:ext cx="8127360" cy="5468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IN" sz="1000" b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Figure S2  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Average crossover and non-crossover counts on chromosomes for wild type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Δ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and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Δ pch2Δ.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</a:t>
            </a:r>
            <a:r>
              <a:rPr lang="en-IN" sz="1000" b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 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The data are compared separately to wild type for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Δ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(A,D)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Δ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(B,E) and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Δ pch2Δ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(C,F).  Significant differences (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&lt; 0.05, </a:t>
            </a:r>
            <a:r>
              <a:rPr lang="en-IN" sz="1000" b="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t-test) 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elative to wild type are shown with asterisk symbol (*).  Error bars are 'mean ± std. error'.</a:t>
            </a:r>
            <a:endParaRPr lang="en-IN" sz="1800" b="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1026" name="Picture 2" descr="F:\Condense supplement\Figure_S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3160" y="548680"/>
            <a:ext cx="7254240" cy="52401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7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jith V P</dc:creator>
  <dc:description/>
  <cp:lastModifiedBy>IISRTVM</cp:lastModifiedBy>
  <cp:revision>6</cp:revision>
  <dcterms:created xsi:type="dcterms:W3CDTF">2017-03-07T07:22:00Z</dcterms:created>
  <dcterms:modified xsi:type="dcterms:W3CDTF">2017-03-10T10:57:03Z</dcterms:modified>
  <dc:language>en-IN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On-screen Show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